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AC7329-32B7-48F1-B019-DFBF3679877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E7917E-7E50-453B-A584-53E46340A1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EAD159-3EA8-4040-8630-3E0A8E6A564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046ED-2EF8-4146-8552-4AA0EAB7F01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926954-21D4-4B1D-8A95-A152647801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099A6-A215-4B3D-94B6-C119BDFF92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037B4A-FC17-44D0-96DE-94A7410BC4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323076-570C-42B6-BDAD-9E556298E0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1B2AF-CD68-4F77-87BB-6654781018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038F8-733F-446E-B9CA-DEAAA3EF2B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AF2D3A-7BA8-447E-9CAC-C93DD9E693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649488-D087-473F-94BD-B4D1115B3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19F57E1-60FA-415A-A323-C851B647842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906640" y="1201680"/>
            <a:ext cx="8366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ucose-6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2286000" y="3335400"/>
            <a:ext cx="12510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phosphoenolpyruv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2157480" y="2336760"/>
            <a:ext cx="15526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1,3-biphosphoglyce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2368440" y="2666880"/>
            <a:ext cx="11559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3-phosphoglyce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2376360" y="2992320"/>
            <a:ext cx="11541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2-phosphoglyce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2644920" y="3665520"/>
            <a:ext cx="7030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Times New Roman"/>
              </a:rPr>
              <a:t>pyruv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2698200" y="4576680"/>
            <a:ext cx="6555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acetyl-Co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2311560" y="4927680"/>
            <a:ext cx="1514160" cy="1411200"/>
          </a:xfrm>
          <a:prstGeom prst="ellipse">
            <a:avLst/>
          </a:prstGeom>
          <a:noFill/>
          <a:ln w="9360">
            <a:solidFill>
              <a:srgbClr val="991b26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3251160" y="4927680"/>
            <a:ext cx="4636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it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3462480" y="5345280"/>
            <a:ext cx="6476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isocit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3279600" y="5796000"/>
            <a:ext cx="9129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2-ketogluta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3098880" y="6151680"/>
            <a:ext cx="7509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uc-Co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2297160" y="6119640"/>
            <a:ext cx="7016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uccin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2017800" y="5784840"/>
            <a:ext cx="7016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umar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2065320" y="5448240"/>
            <a:ext cx="5619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mal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2147760" y="5073480"/>
            <a:ext cx="7747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oxaloace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 flipH="1" flipV="1">
            <a:off x="2954520" y="4132080"/>
            <a:ext cx="699480" cy="835200"/>
          </a:xfrm>
          <a:custGeom>
            <a:avLst/>
            <a:gdLst/>
            <a:ahLst/>
            <a:rect l="l" t="t" r="r" b="b"/>
            <a:pathLst>
              <a:path stroke="0" w="21600" h="21600">
                <a:moveTo>
                  <a:pt x="15054" y="873"/>
                </a:moveTo>
                <a:arcTo wR="10800" hR="10800" stAng="-4008359" swAng="2339589"/>
                <a:lnTo>
                  <a:pt x="10800" y="10800"/>
                </a:lnTo>
                <a:close/>
              </a:path>
              <a:path fill="none" w="21600" h="21600">
                <a:moveTo>
                  <a:pt x="15054" y="873"/>
                </a:moveTo>
                <a:arcTo wR="10800" hR="10800" stAng="-4008359" swAng="2339589"/>
              </a:path>
            </a:pathLst>
          </a:custGeom>
          <a:noFill/>
          <a:ln w="3240">
            <a:solidFill>
              <a:srgbClr val="991b26"/>
            </a:solidFill>
            <a:miter/>
            <a:headEnd len="med" type="triangle" w="sm"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732040" y="5465880"/>
            <a:ext cx="596880" cy="271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lnSpc>
                <a:spcPct val="75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TCA CYCL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517840" y="1998720"/>
            <a:ext cx="11937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yceraldehyde-3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1944720" y="1206360"/>
            <a:ext cx="9334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ructose-6-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1920960" y="1523880"/>
            <a:ext cx="98424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ructose-1,6-P</a:t>
            </a:r>
            <a:r>
              <a:rPr b="0" lang="en-US" sz="8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2" name=""/>
          <p:cNvGrpSpPr/>
          <p:nvPr/>
        </p:nvGrpSpPr>
        <p:grpSpPr>
          <a:xfrm>
            <a:off x="2201760" y="1681200"/>
            <a:ext cx="420480" cy="344160"/>
            <a:chOff x="2201760" y="1681200"/>
            <a:chExt cx="420480" cy="344160"/>
          </a:xfrm>
        </p:grpSpPr>
        <p:sp>
          <p:nvSpPr>
            <p:cNvPr id="63" name=""/>
            <p:cNvSpPr/>
            <p:nvPr/>
          </p:nvSpPr>
          <p:spPr>
            <a:xfrm flipH="1">
              <a:off x="2201760" y="1819800"/>
              <a:ext cx="210240" cy="205560"/>
            </a:xfrm>
            <a:prstGeom prst="line">
              <a:avLst/>
            </a:prstGeom>
            <a:ln w="3240">
              <a:solidFill>
                <a:srgbClr val="991b26"/>
              </a:solidFill>
              <a:miter/>
              <a:tail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412000" y="1681200"/>
              <a:ext cx="0" cy="142560"/>
            </a:xfrm>
            <a:prstGeom prst="line">
              <a:avLst/>
            </a:prstGeom>
            <a:ln w="3240">
              <a:solidFill>
                <a:srgbClr val="991b2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412000" y="1819800"/>
              <a:ext cx="210240" cy="205560"/>
            </a:xfrm>
            <a:prstGeom prst="line">
              <a:avLst/>
            </a:prstGeom>
            <a:ln w="3240">
              <a:solidFill>
                <a:srgbClr val="991b26"/>
              </a:solidFill>
              <a:miter/>
              <a:tailEnd len="med" type="triangle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66" name=""/>
          <p:cNvSpPr/>
          <p:nvPr/>
        </p:nvSpPr>
        <p:spPr>
          <a:xfrm>
            <a:off x="1123920" y="1998720"/>
            <a:ext cx="11527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dihydroxyacetone-3-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 flipH="1">
            <a:off x="2220480" y="2066760"/>
            <a:ext cx="368280" cy="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4262400" y="484200"/>
            <a:ext cx="2843280" cy="1477800"/>
          </a:xfrm>
          <a:prstGeom prst="rect">
            <a:avLst/>
          </a:prstGeom>
          <a:solidFill>
            <a:srgbClr val="cc99ff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4394520" y="1766880"/>
            <a:ext cx="2612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Non-oxidative Branch of the Pentose Phosphate Pathway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3186000" y="3274920"/>
            <a:ext cx="11224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orm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103720" y="893880"/>
            <a:ext cx="7779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xylulose-5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4994280" y="1317600"/>
            <a:ext cx="11224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yceraldehyde-3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5735520" y="557280"/>
            <a:ext cx="9241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edoheptulose-7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4192560" y="1612800"/>
            <a:ext cx="6778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ructose-6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5562720" y="1123920"/>
            <a:ext cx="8413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erythrose-4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5056200" y="1631880"/>
            <a:ext cx="9604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ructose-1,6-bis-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 flipH="1">
            <a:off x="4894200" y="998640"/>
            <a:ext cx="293760" cy="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4402080" y="519120"/>
            <a:ext cx="6318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ribose-5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4788000" y="1724040"/>
            <a:ext cx="350640" cy="64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5384880" y="1007640"/>
            <a:ext cx="0" cy="33804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5384880" y="1469520"/>
            <a:ext cx="0" cy="2206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4305240" y="911160"/>
            <a:ext cx="7254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ribulose-5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 flipV="1">
            <a:off x="4683240" y="671040"/>
            <a:ext cx="0" cy="28116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4894200" y="623880"/>
            <a:ext cx="928800" cy="0"/>
          </a:xfrm>
          <a:prstGeom prst="line">
            <a:avLst/>
          </a:prstGeom>
          <a:ln w="3240">
            <a:solidFill>
              <a:srgbClr val="991b26"/>
            </a:solidFill>
            <a:miter/>
            <a:headEnd len="med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3567240" y="1309680"/>
            <a:ext cx="841320" cy="336600"/>
          </a:xfrm>
          <a:prstGeom prst="line">
            <a:avLst/>
          </a:prstGeom>
          <a:ln w="3240">
            <a:solidFill>
              <a:srgbClr val="991b26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 flipH="1">
            <a:off x="2647440" y="1297080"/>
            <a:ext cx="422280" cy="0"/>
          </a:xfrm>
          <a:prstGeom prst="line">
            <a:avLst/>
          </a:prstGeom>
          <a:ln w="3240">
            <a:solidFill>
              <a:srgbClr val="991b26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 flipV="1">
            <a:off x="3216240" y="3448080"/>
            <a:ext cx="465120" cy="280800"/>
          </a:xfrm>
          <a:prstGeom prst="line">
            <a:avLst/>
          </a:prstGeom>
          <a:ln w="3240">
            <a:solidFill>
              <a:srgbClr val="009999"/>
            </a:solidFill>
            <a:miter/>
            <a:tailEnd len="med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 flipV="1">
            <a:off x="5405400" y="1220760"/>
            <a:ext cx="324000" cy="792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5946840" y="1700280"/>
            <a:ext cx="981000" cy="0"/>
          </a:xfrm>
          <a:prstGeom prst="line">
            <a:avLst/>
          </a:prstGeom>
          <a:ln w="3240">
            <a:solidFill>
              <a:srgbClr val="991b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 flipH="1" flipV="1">
            <a:off x="6436800" y="692280"/>
            <a:ext cx="490680" cy="100800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 flipV="1">
            <a:off x="6226200" y="893520"/>
            <a:ext cx="280800" cy="268200"/>
          </a:xfrm>
          <a:prstGeom prst="line">
            <a:avLst/>
          </a:prstGeom>
          <a:ln w="3240">
            <a:solidFill>
              <a:srgbClr val="991b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 flipH="1" flipV="1">
            <a:off x="6367320" y="825480"/>
            <a:ext cx="139680" cy="68400"/>
          </a:xfrm>
          <a:prstGeom prst="line">
            <a:avLst/>
          </a:prstGeom>
          <a:ln w="3240">
            <a:solidFill>
              <a:srgbClr val="991b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600" bIns="216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 flipH="1" flipV="1">
            <a:off x="5524560" y="623520"/>
            <a:ext cx="210960" cy="135000"/>
          </a:xfrm>
          <a:prstGeom prst="line">
            <a:avLst/>
          </a:prstGeom>
          <a:ln w="3240">
            <a:solidFill>
              <a:srgbClr val="991b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5454720" y="623880"/>
            <a:ext cx="69840" cy="27000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 flipV="1">
            <a:off x="2984400" y="3514680"/>
            <a:ext cx="0" cy="20160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 flipH="1">
            <a:off x="3929040" y="3375000"/>
            <a:ext cx="774720" cy="144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295280" y="2587680"/>
            <a:ext cx="11937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ycerol-3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 flipH="1">
            <a:off x="1755720" y="2189160"/>
            <a:ext cx="884160" cy="42372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 flipV="1">
            <a:off x="3274920" y="4506840"/>
            <a:ext cx="319320" cy="16992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3373920" y="4354560"/>
            <a:ext cx="5184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acetyl-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3305520" y="3859200"/>
            <a:ext cx="6753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ACE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 flipH="1" flipV="1">
            <a:off x="3625560" y="4038120"/>
            <a:ext cx="4680" cy="36828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4265640" y="3281400"/>
            <a:ext cx="1122480" cy="22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O</a:t>
            </a:r>
            <a:r>
              <a:rPr b="0" lang="en-US" sz="800" spc="-1" strike="noStrike" baseline="-25000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 flipV="1">
            <a:off x="2982960" y="3836880"/>
            <a:ext cx="7920" cy="80640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410000" y="4240080"/>
            <a:ext cx="3386160" cy="2084400"/>
          </a:xfrm>
          <a:prstGeom prst="rect">
            <a:avLst/>
          </a:prstGeom>
          <a:solidFill>
            <a:srgbClr val="b2b2b2"/>
          </a:solidFill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448160" y="6093000"/>
            <a:ext cx="12859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Amino Acid catabolism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4380480" y="5775480"/>
            <a:ext cx="5608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SER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6921720" y="5778360"/>
            <a:ext cx="5425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pyruv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4386960" y="4638600"/>
            <a:ext cx="7988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ASPAR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6913440" y="4648320"/>
            <a:ext cx="9417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fumarate+argin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4381200" y="4286160"/>
            <a:ext cx="8535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ASPARAG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6921720" y="4299120"/>
            <a:ext cx="5472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aspar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4380840" y="5613480"/>
            <a:ext cx="6462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PROL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6921000" y="5600880"/>
            <a:ext cx="5882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utam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5532480" y="703440"/>
            <a:ext cx="10206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yceraldehyde-3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628560" y="228600"/>
            <a:ext cx="7334280" cy="6350040"/>
          </a:xfrm>
          <a:prstGeom prst="rect">
            <a:avLst/>
          </a:prstGeom>
          <a:noFill/>
          <a:ln w="57240">
            <a:solidFill>
              <a:srgbClr val="991b2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 flipV="1">
            <a:off x="2193120" y="3784320"/>
            <a:ext cx="585720" cy="33804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1610280" y="4075200"/>
            <a:ext cx="6753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LAC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 flipH="1" flipV="1">
            <a:off x="1904760" y="4260600"/>
            <a:ext cx="4680" cy="36828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1539720" y="4608360"/>
            <a:ext cx="80028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L-lactaldehyd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 flipV="1">
            <a:off x="3129120" y="4061880"/>
            <a:ext cx="363240" cy="55116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 flipV="1">
            <a:off x="2997360" y="2854440"/>
            <a:ext cx="0" cy="20160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 flipH="1">
            <a:off x="1238400" y="3460680"/>
            <a:ext cx="1163520" cy="0"/>
          </a:xfrm>
          <a:prstGeom prst="line">
            <a:avLst/>
          </a:prstGeom>
          <a:ln w="3240">
            <a:solidFill>
              <a:srgbClr val="991b26"/>
            </a:solidFill>
            <a:prstDash val="dashDot"/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 flipH="1">
            <a:off x="1215720" y="5178600"/>
            <a:ext cx="1028520" cy="0"/>
          </a:xfrm>
          <a:prstGeom prst="line">
            <a:avLst/>
          </a:prstGeom>
          <a:ln w="3240">
            <a:solidFill>
              <a:srgbClr val="991b26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 flipV="1">
            <a:off x="1211400" y="3460320"/>
            <a:ext cx="0" cy="1714680"/>
          </a:xfrm>
          <a:prstGeom prst="line">
            <a:avLst/>
          </a:prstGeom>
          <a:ln w="3240">
            <a:solidFill>
              <a:srgbClr val="991b26"/>
            </a:solidFill>
            <a:prstDash val="dash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 flipV="1">
            <a:off x="2997360" y="2523960"/>
            <a:ext cx="0" cy="20160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 flipV="1">
            <a:off x="3009960" y="2181240"/>
            <a:ext cx="0" cy="20160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 flipV="1">
            <a:off x="2997360" y="3152880"/>
            <a:ext cx="0" cy="20160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9" name=""/>
          <p:cNvSpPr/>
          <p:nvPr/>
        </p:nvSpPr>
        <p:spPr>
          <a:xfrm>
            <a:off x="4381200" y="5143680"/>
            <a:ext cx="9615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GLUCOSAM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0" name=""/>
          <p:cNvSpPr/>
          <p:nvPr/>
        </p:nvSpPr>
        <p:spPr>
          <a:xfrm>
            <a:off x="6921360" y="5124600"/>
            <a:ext cx="5943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utam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1" name=""/>
          <p:cNvSpPr/>
          <p:nvPr/>
        </p:nvSpPr>
        <p:spPr>
          <a:xfrm>
            <a:off x="4380480" y="5302080"/>
            <a:ext cx="8215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GLUTAM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2" name=""/>
          <p:cNvSpPr/>
          <p:nvPr/>
        </p:nvSpPr>
        <p:spPr>
          <a:xfrm>
            <a:off x="6921000" y="5276880"/>
            <a:ext cx="5882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glutam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3" name=""/>
          <p:cNvSpPr/>
          <p:nvPr/>
        </p:nvSpPr>
        <p:spPr>
          <a:xfrm>
            <a:off x="5286240" y="5384880"/>
            <a:ext cx="1671840" cy="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"/>
          <p:cNvSpPr/>
          <p:nvPr/>
        </p:nvSpPr>
        <p:spPr>
          <a:xfrm>
            <a:off x="4374000" y="4981680"/>
            <a:ext cx="7027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CYSTE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6923160" y="4959360"/>
            <a:ext cx="4269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er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 flipV="1">
            <a:off x="5280120" y="5073480"/>
            <a:ext cx="1697040" cy="648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 flipH="1" flipV="1">
            <a:off x="3274920" y="3770280"/>
            <a:ext cx="1911600" cy="2376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5065560" y="3681360"/>
            <a:ext cx="1122480" cy="33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isoleucine, leucine,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valine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5415120" y="2001960"/>
            <a:ext cx="9360" cy="717480"/>
          </a:xfrm>
          <a:prstGeom prst="line">
            <a:avLst/>
          </a:prstGeom>
          <a:ln w="28440">
            <a:solidFill>
              <a:srgbClr val="991b26"/>
            </a:solidFill>
            <a:prstDash val="sysDot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4892760" y="2664000"/>
            <a:ext cx="1122120" cy="94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PRPP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chorismate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tryptophan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phenylalan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tyros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histid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purine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3397320" y="2784600"/>
            <a:ext cx="770040" cy="612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3949560" y="2682720"/>
            <a:ext cx="72576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ser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4380840" y="4816440"/>
            <a:ext cx="7988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ASPAR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6922440" y="4832280"/>
            <a:ext cx="42840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lys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4380840" y="4460760"/>
            <a:ext cx="7988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ASPART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6922080" y="4451400"/>
            <a:ext cx="48024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alan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286240" y="4565520"/>
            <a:ext cx="1722600" cy="64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3435480" y="2092320"/>
            <a:ext cx="484200" cy="64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3882960" y="1976400"/>
            <a:ext cx="703440" cy="33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Glycerolipid metabolism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3295800" y="4708440"/>
            <a:ext cx="484200" cy="64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3654360" y="4573440"/>
            <a:ext cx="760320" cy="332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Fatty Acid Biosynthesi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 flipH="1" flipV="1">
            <a:off x="2333520" y="1363680"/>
            <a:ext cx="6480" cy="22392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 flipH="1" flipV="1">
            <a:off x="2473200" y="1376280"/>
            <a:ext cx="6480" cy="223920"/>
          </a:xfrm>
          <a:prstGeom prst="line">
            <a:avLst/>
          </a:prstGeom>
          <a:ln w="3240">
            <a:solidFill>
              <a:srgbClr val="991b26"/>
            </a:solidFill>
            <a:miter/>
            <a:head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2333520" y="1335240"/>
            <a:ext cx="293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X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2701800" y="11700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70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3711600" y="13032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70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1984320" y="142416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927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2085840" y="17035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70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2212920" y="193824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58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2651040" y="21924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59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2657520" y="25416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58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2651040" y="28717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48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2657520" y="317016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84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2638440" y="35323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44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2251080" y="37800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30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860400" y="36781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01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2638440" y="421164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64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3000240" y="421164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70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3565440" y="421164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78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3362400" y="453564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78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1571760" y="43578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53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3127320" y="48150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85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3641760" y="517680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92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3762360" y="56023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635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3552840" y="60469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755-175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2771640" y="631332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637-063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2003400" y="602136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488-049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1965240" y="564048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55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2016000" y="5265720"/>
            <a:ext cx="801720" cy="21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63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442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6683400" y="915840"/>
            <a:ext cx="801720" cy="397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32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50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00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817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5581800" y="2038320"/>
            <a:ext cx="88920" cy="546120"/>
          </a:xfrm>
          <a:custGeom>
            <a:avLst/>
            <a:gdLst>
              <a:gd name="textAreaLeft" fmla="*/ 56880 w 88920"/>
              <a:gd name="textAreaRight" fmla="*/ 89280 w 88920"/>
              <a:gd name="textAreaTop" fmla="*/ 14040 h 546120"/>
              <a:gd name="textAreaBottom" fmla="*/ 532080 h 5461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5603760" y="2039760"/>
            <a:ext cx="1893960" cy="54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Please note that multiple steps are involved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853  CJE0125  CJE0361  CJE0816  CJE1088  CJE0063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454  CJE0436  CJE0974  CJE1806  CJE0395  CJE0394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396  CJE0606  CJE0397  CJE0398  CJE1769  CJE1773  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510  CJE1772  CJE1775  CJE1771  CJE0362  CJE177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770  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6019920" y="3549600"/>
            <a:ext cx="88920" cy="425520"/>
          </a:xfrm>
          <a:custGeom>
            <a:avLst/>
            <a:gdLst>
              <a:gd name="textAreaLeft" fmla="*/ 56880 w 88920"/>
              <a:gd name="textAreaRight" fmla="*/ 89280 w 88920"/>
              <a:gd name="textAreaTop" fmla="*/ 10800 h 425520"/>
              <a:gd name="textAreaBottom" fmla="*/ 414720 h 425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5400" y="10800"/>
                  <a:pt x="0" y="10800"/>
                </a:cubicBezTo>
                <a:cubicBezTo>
                  <a:pt x="54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6022800" y="3557520"/>
            <a:ext cx="1893960" cy="473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Please note that multiple steps are involved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678  CJE0677  CJE0735  CJE0012  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318  CJE1886  CJE1887  CJE188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88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3279600" y="264960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970, CJE0371, CJE033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3844800" y="324000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970, CJE0371, CJE033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3300480" y="3438360"/>
            <a:ext cx="2311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?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5286240" y="428148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02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 flipV="1">
            <a:off x="5286240" y="4406760"/>
            <a:ext cx="1716120" cy="1296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5286240" y="4737240"/>
            <a:ext cx="1703520" cy="612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5280120" y="4940280"/>
            <a:ext cx="1722240" cy="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5286240" y="5556240"/>
            <a:ext cx="1659240" cy="64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5286240" y="5245200"/>
            <a:ext cx="1677960" cy="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5280120" y="5886360"/>
            <a:ext cx="1677960" cy="648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5286240" y="443376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34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5286240" y="460548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082, CJE0767, CJE100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5286240" y="5715000"/>
            <a:ext cx="1710000" cy="12600"/>
          </a:xfrm>
          <a:prstGeom prst="line">
            <a:avLst/>
          </a:prstGeom>
          <a:ln w="3240">
            <a:solidFill>
              <a:srgbClr val="991b26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4380480" y="5454720"/>
            <a:ext cx="8503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Times New Roman"/>
              </a:rPr>
              <a:t>GLUTAMAT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6921720" y="5454720"/>
            <a:ext cx="474120" cy="210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360" rIns="90360" tIns="44280" bIns="4428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</a:rPr>
              <a:t>proline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5267160" y="4821120"/>
            <a:ext cx="221148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685, CJE1167, CJE0897, CJE0532, CJE0190, CJE035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5286240" y="495468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854, CJE0451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5286240" y="512604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55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5286240" y="527832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798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5286240" y="558972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67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5286240" y="542448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0092, CJE0662, CJE1219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5286240" y="5767560"/>
            <a:ext cx="114480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796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1717560" y="2357280"/>
            <a:ext cx="801720" cy="16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Times New Roman"/>
              </a:rPr>
              <a:t>CJE1330</a:t>
            </a:r>
            <a:endParaRPr b="0" lang="en-US" sz="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4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03-17T14:25:55Z</dcterms:created>
  <dc:creator>Karen Nelson</dc:creator>
  <dc:description/>
  <dc:language>en-US</dc:language>
  <cp:lastModifiedBy>Karen Nelson</cp:lastModifiedBy>
  <cp:lastPrinted>2004-10-21T15:58:45Z</cp:lastPrinted>
  <dcterms:modified xsi:type="dcterms:W3CDTF">2004-10-21T18:07:32Z</dcterms:modified>
  <cp:revision>128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358108391</vt:r8>
  </property>
  <property fmtid="{D5CDD505-2E9C-101B-9397-08002B2CF9AE}" pid="3" name="_AuthorEmail">
    <vt:lpwstr>BMethe@tigr.org</vt:lpwstr>
  </property>
  <property fmtid="{D5CDD505-2E9C-101B-9397-08002B2CF9AE}" pid="4" name="_AuthorEmailDisplayName">
    <vt:lpwstr>Methe, Barbara</vt:lpwstr>
  </property>
  <property fmtid="{D5CDD505-2E9C-101B-9397-08002B2CF9AE}" pid="5" name="_EmailSubject">
    <vt:lpwstr>Figure as submitted to Science</vt:lpwstr>
  </property>
</Properties>
</file>